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25" r:id="rId2"/>
  </p:sldIdLst>
  <p:sldSz cx="15544800" cy="20116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336" userDrawn="1">
          <p15:clr>
            <a:srgbClr val="A4A3A4"/>
          </p15:clr>
        </p15:guide>
        <p15:guide id="2" pos="48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BA22"/>
    <a:srgbClr val="C2282E"/>
    <a:srgbClr val="CE9054"/>
    <a:srgbClr val="A38CC3"/>
    <a:srgbClr val="DA9958"/>
    <a:srgbClr val="4FAB2A"/>
    <a:srgbClr val="DECAFF"/>
    <a:srgbClr val="CBB9E9"/>
    <a:srgbClr val="E7E6E6"/>
    <a:srgbClr val="EAAF7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06"/>
    <p:restoredTop sz="95405"/>
  </p:normalViewPr>
  <p:slideViewPr>
    <p:cSldViewPr snapToGrid="0">
      <p:cViewPr>
        <p:scale>
          <a:sx n="95" d="100"/>
          <a:sy n="95" d="100"/>
        </p:scale>
        <p:origin x="520" y="144"/>
      </p:cViewPr>
      <p:guideLst>
        <p:guide orient="horz" pos="6336"/>
        <p:guide pos="48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2921F5-EBEB-A54A-BA47-17688F59D63E}" type="datetimeFigureOut">
              <a:rPr lang="en-US" smtClean="0"/>
              <a:t>1/29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30FBF3-0045-144D-A49E-01FC61F4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96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4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8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32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76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20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4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8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52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3292265"/>
            <a:ext cx="13213080" cy="7003627"/>
          </a:xfrm>
        </p:spPr>
        <p:txBody>
          <a:bodyPr anchor="b"/>
          <a:lstStyle>
            <a:lvl1pPr algn="ctr">
              <a:defRPr sz="10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10565978"/>
            <a:ext cx="11658600" cy="4856902"/>
          </a:xfrm>
        </p:spPr>
        <p:txBody>
          <a:bodyPr/>
          <a:lstStyle>
            <a:lvl1pPr marL="0" indent="0" algn="ctr">
              <a:buNone/>
              <a:defRPr sz="4080"/>
            </a:lvl1pPr>
            <a:lvl2pPr marL="777240" indent="0" algn="ctr">
              <a:buNone/>
              <a:defRPr sz="3400"/>
            </a:lvl2pPr>
            <a:lvl3pPr marL="1554480" indent="0" algn="ctr">
              <a:buNone/>
              <a:defRPr sz="3060"/>
            </a:lvl3pPr>
            <a:lvl4pPr marL="2331720" indent="0" algn="ctr">
              <a:buNone/>
              <a:defRPr sz="2720"/>
            </a:lvl4pPr>
            <a:lvl5pPr marL="3108960" indent="0" algn="ctr">
              <a:buNone/>
              <a:defRPr sz="2720"/>
            </a:lvl5pPr>
            <a:lvl6pPr marL="3886200" indent="0" algn="ctr">
              <a:buNone/>
              <a:defRPr sz="2720"/>
            </a:lvl6pPr>
            <a:lvl7pPr marL="4663440" indent="0" algn="ctr">
              <a:buNone/>
              <a:defRPr sz="2720"/>
            </a:lvl7pPr>
            <a:lvl8pPr marL="5440680" indent="0" algn="ctr">
              <a:buNone/>
              <a:defRPr sz="2720"/>
            </a:lvl8pPr>
            <a:lvl9pPr marL="6217920" indent="0" algn="ctr">
              <a:buNone/>
              <a:defRPr sz="27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882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368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1071033"/>
            <a:ext cx="3351848" cy="1704805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1071033"/>
            <a:ext cx="9861233" cy="1704805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982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957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5015236"/>
            <a:ext cx="13407390" cy="8368029"/>
          </a:xfrm>
        </p:spPr>
        <p:txBody>
          <a:bodyPr anchor="b"/>
          <a:lstStyle>
            <a:lvl1pPr>
              <a:defRPr sz="10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13462429"/>
            <a:ext cx="13407390" cy="4400549"/>
          </a:xfrm>
        </p:spPr>
        <p:txBody>
          <a:bodyPr/>
          <a:lstStyle>
            <a:lvl1pPr marL="0" indent="0">
              <a:buNone/>
              <a:defRPr sz="4080">
                <a:solidFill>
                  <a:schemeClr val="tx1"/>
                </a:solidFill>
              </a:defRPr>
            </a:lvl1pPr>
            <a:lvl2pPr marL="77724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2pPr>
            <a:lvl3pPr marL="1554480" indent="0">
              <a:buNone/>
              <a:defRPr sz="3060">
                <a:solidFill>
                  <a:schemeClr val="tx1">
                    <a:tint val="75000"/>
                  </a:schemeClr>
                </a:solidFill>
              </a:defRPr>
            </a:lvl3pPr>
            <a:lvl4pPr marL="233172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4pPr>
            <a:lvl5pPr marL="310896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5pPr>
            <a:lvl6pPr marL="388620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6pPr>
            <a:lvl7pPr marL="466344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7pPr>
            <a:lvl8pPr marL="544068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8pPr>
            <a:lvl9pPr marL="621792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643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5355167"/>
            <a:ext cx="6606540" cy="127639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5355167"/>
            <a:ext cx="6606540" cy="127639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591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071038"/>
            <a:ext cx="13407390" cy="388831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4931411"/>
            <a:ext cx="6576178" cy="2416809"/>
          </a:xfrm>
        </p:spPr>
        <p:txBody>
          <a:bodyPr anchor="b"/>
          <a:lstStyle>
            <a:lvl1pPr marL="0" indent="0">
              <a:buNone/>
              <a:defRPr sz="4080" b="1"/>
            </a:lvl1pPr>
            <a:lvl2pPr marL="777240" indent="0">
              <a:buNone/>
              <a:defRPr sz="3400" b="1"/>
            </a:lvl2pPr>
            <a:lvl3pPr marL="1554480" indent="0">
              <a:buNone/>
              <a:defRPr sz="3060" b="1"/>
            </a:lvl3pPr>
            <a:lvl4pPr marL="2331720" indent="0">
              <a:buNone/>
              <a:defRPr sz="2720" b="1"/>
            </a:lvl4pPr>
            <a:lvl5pPr marL="3108960" indent="0">
              <a:buNone/>
              <a:defRPr sz="2720" b="1"/>
            </a:lvl5pPr>
            <a:lvl6pPr marL="3886200" indent="0">
              <a:buNone/>
              <a:defRPr sz="2720" b="1"/>
            </a:lvl6pPr>
            <a:lvl7pPr marL="4663440" indent="0">
              <a:buNone/>
              <a:defRPr sz="2720" b="1"/>
            </a:lvl7pPr>
            <a:lvl8pPr marL="5440680" indent="0">
              <a:buNone/>
              <a:defRPr sz="2720" b="1"/>
            </a:lvl8pPr>
            <a:lvl9pPr marL="6217920" indent="0">
              <a:buNone/>
              <a:defRPr sz="27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7348220"/>
            <a:ext cx="6576178" cy="108081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4931411"/>
            <a:ext cx="6608565" cy="2416809"/>
          </a:xfrm>
        </p:spPr>
        <p:txBody>
          <a:bodyPr anchor="b"/>
          <a:lstStyle>
            <a:lvl1pPr marL="0" indent="0">
              <a:buNone/>
              <a:defRPr sz="4080" b="1"/>
            </a:lvl1pPr>
            <a:lvl2pPr marL="777240" indent="0">
              <a:buNone/>
              <a:defRPr sz="3400" b="1"/>
            </a:lvl2pPr>
            <a:lvl3pPr marL="1554480" indent="0">
              <a:buNone/>
              <a:defRPr sz="3060" b="1"/>
            </a:lvl3pPr>
            <a:lvl4pPr marL="2331720" indent="0">
              <a:buNone/>
              <a:defRPr sz="2720" b="1"/>
            </a:lvl4pPr>
            <a:lvl5pPr marL="3108960" indent="0">
              <a:buNone/>
              <a:defRPr sz="2720" b="1"/>
            </a:lvl5pPr>
            <a:lvl6pPr marL="3886200" indent="0">
              <a:buNone/>
              <a:defRPr sz="2720" b="1"/>
            </a:lvl6pPr>
            <a:lvl7pPr marL="4663440" indent="0">
              <a:buNone/>
              <a:defRPr sz="2720" b="1"/>
            </a:lvl7pPr>
            <a:lvl8pPr marL="5440680" indent="0">
              <a:buNone/>
              <a:defRPr sz="2720" b="1"/>
            </a:lvl8pPr>
            <a:lvl9pPr marL="6217920" indent="0">
              <a:buNone/>
              <a:defRPr sz="27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7348220"/>
            <a:ext cx="6608565" cy="108081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25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275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332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341120"/>
            <a:ext cx="5013603" cy="4693920"/>
          </a:xfrm>
        </p:spPr>
        <p:txBody>
          <a:bodyPr anchor="b"/>
          <a:lstStyle>
            <a:lvl1pPr>
              <a:defRPr sz="5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2896451"/>
            <a:ext cx="7869555" cy="14295967"/>
          </a:xfrm>
        </p:spPr>
        <p:txBody>
          <a:bodyPr/>
          <a:lstStyle>
            <a:lvl1pPr>
              <a:defRPr sz="5440"/>
            </a:lvl1pPr>
            <a:lvl2pPr>
              <a:defRPr sz="4760"/>
            </a:lvl2pPr>
            <a:lvl3pPr>
              <a:defRPr sz="408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6035040"/>
            <a:ext cx="5013603" cy="11180658"/>
          </a:xfrm>
        </p:spPr>
        <p:txBody>
          <a:bodyPr/>
          <a:lstStyle>
            <a:lvl1pPr marL="0" indent="0">
              <a:buNone/>
              <a:defRPr sz="2720"/>
            </a:lvl1pPr>
            <a:lvl2pPr marL="777240" indent="0">
              <a:buNone/>
              <a:defRPr sz="2380"/>
            </a:lvl2pPr>
            <a:lvl3pPr marL="1554480" indent="0">
              <a:buNone/>
              <a:defRPr sz="2040"/>
            </a:lvl3pPr>
            <a:lvl4pPr marL="2331720" indent="0">
              <a:buNone/>
              <a:defRPr sz="1700"/>
            </a:lvl4pPr>
            <a:lvl5pPr marL="3108960" indent="0">
              <a:buNone/>
              <a:defRPr sz="1700"/>
            </a:lvl5pPr>
            <a:lvl6pPr marL="3886200" indent="0">
              <a:buNone/>
              <a:defRPr sz="1700"/>
            </a:lvl6pPr>
            <a:lvl7pPr marL="4663440" indent="0">
              <a:buNone/>
              <a:defRPr sz="1700"/>
            </a:lvl7pPr>
            <a:lvl8pPr marL="5440680" indent="0">
              <a:buNone/>
              <a:defRPr sz="1700"/>
            </a:lvl8pPr>
            <a:lvl9pPr marL="6217920" indent="0">
              <a:buNone/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620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341120"/>
            <a:ext cx="5013603" cy="4693920"/>
          </a:xfrm>
        </p:spPr>
        <p:txBody>
          <a:bodyPr anchor="b"/>
          <a:lstStyle>
            <a:lvl1pPr>
              <a:defRPr sz="5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2896451"/>
            <a:ext cx="7869555" cy="14295967"/>
          </a:xfrm>
        </p:spPr>
        <p:txBody>
          <a:bodyPr anchor="t"/>
          <a:lstStyle>
            <a:lvl1pPr marL="0" indent="0">
              <a:buNone/>
              <a:defRPr sz="5440"/>
            </a:lvl1pPr>
            <a:lvl2pPr marL="777240" indent="0">
              <a:buNone/>
              <a:defRPr sz="4760"/>
            </a:lvl2pPr>
            <a:lvl3pPr marL="1554480" indent="0">
              <a:buNone/>
              <a:defRPr sz="4080"/>
            </a:lvl3pPr>
            <a:lvl4pPr marL="2331720" indent="0">
              <a:buNone/>
              <a:defRPr sz="3400"/>
            </a:lvl4pPr>
            <a:lvl5pPr marL="3108960" indent="0">
              <a:buNone/>
              <a:defRPr sz="3400"/>
            </a:lvl5pPr>
            <a:lvl6pPr marL="3886200" indent="0">
              <a:buNone/>
              <a:defRPr sz="3400"/>
            </a:lvl6pPr>
            <a:lvl7pPr marL="4663440" indent="0">
              <a:buNone/>
              <a:defRPr sz="3400"/>
            </a:lvl7pPr>
            <a:lvl8pPr marL="5440680" indent="0">
              <a:buNone/>
              <a:defRPr sz="3400"/>
            </a:lvl8pPr>
            <a:lvl9pPr marL="6217920" indent="0">
              <a:buNone/>
              <a:defRPr sz="3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6035040"/>
            <a:ext cx="5013603" cy="11180658"/>
          </a:xfrm>
        </p:spPr>
        <p:txBody>
          <a:bodyPr/>
          <a:lstStyle>
            <a:lvl1pPr marL="0" indent="0">
              <a:buNone/>
              <a:defRPr sz="2720"/>
            </a:lvl1pPr>
            <a:lvl2pPr marL="777240" indent="0">
              <a:buNone/>
              <a:defRPr sz="2380"/>
            </a:lvl2pPr>
            <a:lvl3pPr marL="1554480" indent="0">
              <a:buNone/>
              <a:defRPr sz="2040"/>
            </a:lvl3pPr>
            <a:lvl4pPr marL="2331720" indent="0">
              <a:buNone/>
              <a:defRPr sz="1700"/>
            </a:lvl4pPr>
            <a:lvl5pPr marL="3108960" indent="0">
              <a:buNone/>
              <a:defRPr sz="1700"/>
            </a:lvl5pPr>
            <a:lvl6pPr marL="3886200" indent="0">
              <a:buNone/>
              <a:defRPr sz="1700"/>
            </a:lvl6pPr>
            <a:lvl7pPr marL="4663440" indent="0">
              <a:buNone/>
              <a:defRPr sz="1700"/>
            </a:lvl7pPr>
            <a:lvl8pPr marL="5440680" indent="0">
              <a:buNone/>
              <a:defRPr sz="1700"/>
            </a:lvl8pPr>
            <a:lvl9pPr marL="6217920" indent="0">
              <a:buNone/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442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1071038"/>
            <a:ext cx="13407390" cy="38883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5355167"/>
            <a:ext cx="13407390" cy="127639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8645298"/>
            <a:ext cx="349758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0E124-13CC-1142-B5EE-D8000C6CCD38}" type="datetimeFigureOut">
              <a:rPr lang="en-US" smtClean="0"/>
              <a:t>1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8645298"/>
            <a:ext cx="524637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8645298"/>
            <a:ext cx="349758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FC850-FD61-BC42-A64D-82D27789B7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533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554480" rtl="0" eaLnBrk="1" latinLnBrk="0" hangingPunct="1">
        <a:lnSpc>
          <a:spcPct val="90000"/>
        </a:lnSpc>
        <a:spcBef>
          <a:spcPct val="0"/>
        </a:spcBef>
        <a:buNone/>
        <a:defRPr sz="74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8620" indent="-388620" algn="l" defTabSz="155448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4760" kern="1200">
          <a:solidFill>
            <a:schemeClr val="tx1"/>
          </a:solidFill>
          <a:latin typeface="+mn-lt"/>
          <a:ea typeface="+mn-ea"/>
          <a:cs typeface="+mn-cs"/>
        </a:defRPr>
      </a:lvl1pPr>
      <a:lvl2pPr marL="116586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4080" kern="1200">
          <a:solidFill>
            <a:schemeClr val="tx1"/>
          </a:solidFill>
          <a:latin typeface="+mn-lt"/>
          <a:ea typeface="+mn-ea"/>
          <a:cs typeface="+mn-cs"/>
        </a:defRPr>
      </a:lvl2pPr>
      <a:lvl3pPr marL="194310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72034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4pPr>
      <a:lvl5pPr marL="349758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5pPr>
      <a:lvl6pPr marL="427482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6pPr>
      <a:lvl7pPr marL="505206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7pPr>
      <a:lvl8pPr marL="582930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8pPr>
      <a:lvl9pPr marL="660654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1pPr>
      <a:lvl2pPr marL="77724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2pPr>
      <a:lvl3pPr marL="155448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3pPr>
      <a:lvl4pPr marL="233172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4pPr>
      <a:lvl5pPr marL="310896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5pPr>
      <a:lvl6pPr marL="388620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6pPr>
      <a:lvl7pPr marL="466344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7pPr>
      <a:lvl8pPr marL="544068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://www.ncbi.nlm.nih.gov/Traces/wgs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487ED1A-6FB9-659E-EC37-E85EA52B4C96}"/>
              </a:ext>
            </a:extLst>
          </p:cNvPr>
          <p:cNvSpPr txBox="1"/>
          <p:nvPr/>
        </p:nvSpPr>
        <p:spPr>
          <a:xfrm>
            <a:off x="1995166" y="1857892"/>
            <a:ext cx="10210800" cy="2912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Gene-specific primers for SYBR green qRT-PCR in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n. amargosae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upfish.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BD7DA4BB-4184-7767-E249-D67C7C1F63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8814562"/>
              </p:ext>
            </p:extLst>
          </p:nvPr>
        </p:nvGraphicFramePr>
        <p:xfrm>
          <a:off x="2205318" y="2149126"/>
          <a:ext cx="10287000" cy="11258012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304364">
                  <a:extLst>
                    <a:ext uri="{9D8B030D-6E8A-4147-A177-3AD203B41FA5}">
                      <a16:colId xmlns:a16="http://schemas.microsoft.com/office/drawing/2014/main" val="1168385349"/>
                    </a:ext>
                  </a:extLst>
                </a:gridCol>
                <a:gridCol w="723423">
                  <a:extLst>
                    <a:ext uri="{9D8B030D-6E8A-4147-A177-3AD203B41FA5}">
                      <a16:colId xmlns:a16="http://schemas.microsoft.com/office/drawing/2014/main" val="738878383"/>
                    </a:ext>
                  </a:extLst>
                </a:gridCol>
                <a:gridCol w="2866942">
                  <a:extLst>
                    <a:ext uri="{9D8B030D-6E8A-4147-A177-3AD203B41FA5}">
                      <a16:colId xmlns:a16="http://schemas.microsoft.com/office/drawing/2014/main" val="1652096858"/>
                    </a:ext>
                  </a:extLst>
                </a:gridCol>
                <a:gridCol w="1613647">
                  <a:extLst>
                    <a:ext uri="{9D8B030D-6E8A-4147-A177-3AD203B41FA5}">
                      <a16:colId xmlns:a16="http://schemas.microsoft.com/office/drawing/2014/main" val="2900084440"/>
                    </a:ext>
                  </a:extLst>
                </a:gridCol>
                <a:gridCol w="1936377">
                  <a:extLst>
                    <a:ext uri="{9D8B030D-6E8A-4147-A177-3AD203B41FA5}">
                      <a16:colId xmlns:a16="http://schemas.microsoft.com/office/drawing/2014/main" val="1393784295"/>
                    </a:ext>
                  </a:extLst>
                </a:gridCol>
                <a:gridCol w="1842247">
                  <a:extLst>
                    <a:ext uri="{9D8B030D-6E8A-4147-A177-3AD203B41FA5}">
                      <a16:colId xmlns:a16="http://schemas.microsoft.com/office/drawing/2014/main" val="1203139705"/>
                    </a:ext>
                  </a:extLst>
                </a:gridCol>
              </a:tblGrid>
              <a:tr h="37665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cript</a:t>
                      </a:r>
                      <a:endParaRPr lang="en-US" sz="12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  <a:endParaRPr lang="en-US" sz="12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otide Sequence (5</a:t>
                      </a: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Symbol" pitchFamily="2" charset="2"/>
                        </a:rPr>
                        <a:t></a:t>
                      </a: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3</a:t>
                      </a: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Symbol" pitchFamily="2" charset="2"/>
                        </a:rPr>
                        <a:t></a:t>
                      </a: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 length (bp)</a:t>
                      </a:r>
                      <a:endParaRPr lang="en-US" sz="12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R efficiency (avg. %)</a:t>
                      </a:r>
                      <a:endParaRPr lang="en-US" sz="12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Bank accession no.</a:t>
                      </a:r>
                      <a:endParaRPr lang="en-US" sz="12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5933635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shb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ACAACAAGGACTCTGCCAT T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9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823457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AGGGTAGATGATGCTTT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3673026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hb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CCAGGGATCTCAACATGA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44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7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8933533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TCAACTCCAGGCAAAC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0802405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shr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TTCCTCTATGCGTTCTT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3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3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1149730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CTCTGTCCTGTAAATCTG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3473096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hcgr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TCACTACAGCCAGAAT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67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2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3503654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AGGGTGGAAAGCGTATA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0664288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GATAAGGTTCTCAGCAAAG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.93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4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2723450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CAGCTCTTCATAAAGG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6108203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11a1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CCCATTTACAGAGAGAA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3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9289464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CACCTTCAGCCGTTTC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5097191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3b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CTTCAGTATTCAGGACA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 bp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88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6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5817142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AATGAACGGTCGTAGA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4864820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17b3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CGCTGTATACCCTCTA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6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41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364471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CCCTCTGTCCTTGTACTC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7986988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11b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GGACGCATCGTCAACA</a:t>
                      </a: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2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7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6416828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GTTTCAGTGAAGAGGTTCA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332333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19a1a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CTACAAGGTCCCAAA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6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Q28359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2740175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TAACGGCGAGGAGTATT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92688971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bg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CAAGGGAAAGTTTGT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9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67488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3161778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AGAAACAACCTCCTTAGT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3471991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p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CAGTTCAGCAGCTAT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8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2225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9767848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AGTACTACCTTCCCAGAAA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1773062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1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TCAAACACTGGCTACTAC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78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SUU01001417*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8771408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CACAAACACAAGAGG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9177586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2a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CCTCTCAGGGTCGAATTA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 bp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77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Q266774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3716782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TCAGTCCAGGTTGTAAA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3221509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2b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CTTCTGGACTCTGTCATT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54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Q26677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8994532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AGCAGCATGGTGAGAT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5545037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tga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AAGACACACTCTACACATTC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78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Q266776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6725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TCATTGGTGCAATCC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0118647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h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TTTGTGAACACCCATAC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5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Q266778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6204819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TTTATACCCTGCCCTGA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374813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hm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GCTTGGCAATGGAGAATG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14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Q26677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2507345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GGGTAGTCAGCTTCTC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6588663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l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TTTGTGAACACCCATACA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13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Q266777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1059682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TTTATACCCTGCCCTGA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1419804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CCTTCCTTGGTATGGAGT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 bp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16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886377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4923249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CAGGTCCTTACGGATGT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1152420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1a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GGGTATTGGACAAACTGA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 bp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.0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90693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7748357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AGTACTTGCTGGTCTCAA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0605645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l8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CCAAGAAGTCCAGAGTCAA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 bp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.66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J719257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334315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GATGGGCTTGTCAATA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5444375"/>
                  </a:ext>
                </a:extLst>
              </a:tr>
              <a:tr h="22860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p</a:t>
                      </a:r>
                      <a:endParaRPr lang="en-US" sz="1200" i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CAGTTCAGCAGCTATG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 bp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8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22225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9600249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AGTACTACCTTCCCAGAAA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904" marR="42904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10033945"/>
                  </a:ext>
                </a:extLst>
              </a:tr>
              <a:tr h="365760">
                <a:tc gridSpan="6">
                  <a:txBody>
                    <a:bodyPr/>
                    <a:lstStyle/>
                    <a:p>
                      <a:pPr marL="0" marR="0" lvl="0" indent="0" algn="l" defTabSz="155448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Whole Genome Shotgun (WGS) assembly sequence entry from </a:t>
                      </a:r>
                      <a:r>
                        <a:rPr lang="en-US" sz="1200" i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yprinodon nevadensis pectoralis 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u="sng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hlinkClick r:id="rId2"/>
                        </a:rPr>
                        <a:t>http://www.ncbi.nlm.nih.gov/Traces/wgs/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4008" marR="42904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2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904" marR="42904" marT="0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342515" algn="l"/>
                        </a:tabLst>
                      </a:pPr>
                      <a:endParaRPr lang="en-US" sz="22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904" marR="42904" marT="0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2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904" marR="42904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2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904" marR="42904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2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904" marR="42904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3138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55731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8110</TotalTime>
  <Words>283</Words>
  <Application>Microsoft Macintosh PowerPoint</Application>
  <PresentationFormat>Custom</PresentationFormat>
  <Paragraphs>19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die Housh</dc:creator>
  <cp:lastModifiedBy>Maddie Housh</cp:lastModifiedBy>
  <cp:revision>122</cp:revision>
  <cp:lastPrinted>2023-05-11T22:01:51Z</cp:lastPrinted>
  <dcterms:created xsi:type="dcterms:W3CDTF">2022-12-12T01:31:14Z</dcterms:created>
  <dcterms:modified xsi:type="dcterms:W3CDTF">2024-01-30T00:15:06Z</dcterms:modified>
</cp:coreProperties>
</file>